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NDB&#12458;&#12540;&#12503;&#12531;&#12487;&#12540;&#12479;&#12398;&#20998;&#26512;\&#21407;&#31295;_%20&#21307;&#30274;&#36027;&#35036;&#21161;&#25919;&#31574;&#12392;&#12501;&#12483;&#21270;&#29289;&#27927;&#21475;\&#12464;&#12521;&#12501;&#20316;&#25104;&#29992;_bmcpb_revision_113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NDB&#12458;&#12540;&#12503;&#12531;&#12487;&#12540;&#12479;&#12398;&#20998;&#26512;\&#21407;&#31295;_%20&#21307;&#30274;&#36027;&#35036;&#21161;&#25919;&#31574;&#12392;&#12501;&#12483;&#21270;&#29289;&#27927;&#21475;\&#12464;&#12521;&#12501;&#20316;&#25104;&#29992;_bmcpb_revision_113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FMRシーラント!$E$1:$E$2</c:f>
              <c:strCache>
                <c:ptCount val="2"/>
                <c:pt idx="1">
                  <c:v>SFMR in 2016</c:v>
                </c:pt>
              </c:strCache>
            </c:strRef>
          </c:tx>
          <c:spPr>
            <a:ln w="28575" cap="rnd">
              <a:solidFill>
                <a:schemeClr val="bg1">
                  <a:lumMod val="50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SFMRシーラント!$D$3:$D$50</c:f>
              <c:numCache>
                <c:formatCode>General</c:formatCode>
                <c:ptCount val="4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SFMRシーラント!$E$3:$E$50</c:f>
              <c:numCache>
                <c:formatCode>General</c:formatCode>
                <c:ptCount val="48"/>
                <c:pt idx="0">
                  <c:v>22</c:v>
                </c:pt>
                <c:pt idx="1">
                  <c:v>4.5999999999999996</c:v>
                </c:pt>
                <c:pt idx="2">
                  <c:v>5.3</c:v>
                </c:pt>
                <c:pt idx="3">
                  <c:v>4.5999999999999996</c:v>
                </c:pt>
                <c:pt idx="4">
                  <c:v>70.8</c:v>
                </c:pt>
                <c:pt idx="5">
                  <c:v>9.1999999999999993</c:v>
                </c:pt>
                <c:pt idx="6">
                  <c:v>4.7</c:v>
                </c:pt>
                <c:pt idx="7">
                  <c:v>0.3</c:v>
                </c:pt>
                <c:pt idx="8">
                  <c:v>7</c:v>
                </c:pt>
                <c:pt idx="9">
                  <c:v>1.9</c:v>
                </c:pt>
                <c:pt idx="10">
                  <c:v>8.6999999999999993</c:v>
                </c:pt>
                <c:pt idx="11">
                  <c:v>3.3</c:v>
                </c:pt>
                <c:pt idx="12">
                  <c:v>0.2</c:v>
                </c:pt>
                <c:pt idx="13">
                  <c:v>0.2</c:v>
                </c:pt>
                <c:pt idx="14">
                  <c:v>63.1</c:v>
                </c:pt>
                <c:pt idx="15">
                  <c:v>33.700000000000003</c:v>
                </c:pt>
                <c:pt idx="16">
                  <c:v>0.6</c:v>
                </c:pt>
                <c:pt idx="17">
                  <c:v>5.9</c:v>
                </c:pt>
                <c:pt idx="18">
                  <c:v>0.8</c:v>
                </c:pt>
                <c:pt idx="19">
                  <c:v>16</c:v>
                </c:pt>
                <c:pt idx="20">
                  <c:v>23.1</c:v>
                </c:pt>
                <c:pt idx="21">
                  <c:v>13.9</c:v>
                </c:pt>
                <c:pt idx="22">
                  <c:v>21.2</c:v>
                </c:pt>
                <c:pt idx="23">
                  <c:v>2.6</c:v>
                </c:pt>
                <c:pt idx="24">
                  <c:v>9.1999999999999993</c:v>
                </c:pt>
                <c:pt idx="25">
                  <c:v>44.2</c:v>
                </c:pt>
                <c:pt idx="26">
                  <c:v>0.1</c:v>
                </c:pt>
                <c:pt idx="27">
                  <c:v>3.1</c:v>
                </c:pt>
                <c:pt idx="28">
                  <c:v>3.9</c:v>
                </c:pt>
                <c:pt idx="29">
                  <c:v>15.3</c:v>
                </c:pt>
                <c:pt idx="30">
                  <c:v>8.9</c:v>
                </c:pt>
                <c:pt idx="31">
                  <c:v>51</c:v>
                </c:pt>
                <c:pt idx="32">
                  <c:v>2.2999999999999998</c:v>
                </c:pt>
                <c:pt idx="33">
                  <c:v>0.6</c:v>
                </c:pt>
                <c:pt idx="34">
                  <c:v>30.9</c:v>
                </c:pt>
                <c:pt idx="35">
                  <c:v>0.2</c:v>
                </c:pt>
                <c:pt idx="36">
                  <c:v>23.2</c:v>
                </c:pt>
                <c:pt idx="37">
                  <c:v>24.3</c:v>
                </c:pt>
                <c:pt idx="38">
                  <c:v>19</c:v>
                </c:pt>
                <c:pt idx="39">
                  <c:v>0.4</c:v>
                </c:pt>
                <c:pt idx="40">
                  <c:v>86.9</c:v>
                </c:pt>
                <c:pt idx="41">
                  <c:v>39.799999999999997</c:v>
                </c:pt>
                <c:pt idx="42">
                  <c:v>54.7</c:v>
                </c:pt>
                <c:pt idx="43">
                  <c:v>4.5</c:v>
                </c:pt>
                <c:pt idx="44">
                  <c:v>50</c:v>
                </c:pt>
                <c:pt idx="45">
                  <c:v>11</c:v>
                </c:pt>
                <c:pt idx="46">
                  <c:v>6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B32-4F18-875A-435F79713202}"/>
            </c:ext>
          </c:extLst>
        </c:ser>
        <c:ser>
          <c:idx val="1"/>
          <c:order val="1"/>
          <c:tx>
            <c:strRef>
              <c:f>SFMRシーラント!$F$1:$F$2</c:f>
              <c:strCache>
                <c:ptCount val="2"/>
                <c:pt idx="1">
                  <c:v>Dental sealant in 2016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FMRシーラント!$D$3:$D$50</c:f>
              <c:numCache>
                <c:formatCode>General</c:formatCode>
                <c:ptCount val="4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SFMRシーラント!$F$3:$F$50</c:f>
              <c:numCache>
                <c:formatCode>General</c:formatCode>
                <c:ptCount val="48"/>
                <c:pt idx="0">
                  <c:v>110.08814801052947</c:v>
                </c:pt>
                <c:pt idx="1">
                  <c:v>76.924152625261968</c:v>
                </c:pt>
                <c:pt idx="2">
                  <c:v>73.898436568684772</c:v>
                </c:pt>
                <c:pt idx="3">
                  <c:v>86.427214717615911</c:v>
                </c:pt>
                <c:pt idx="4">
                  <c:v>82.778809105273126</c:v>
                </c:pt>
                <c:pt idx="5">
                  <c:v>111.30084907279172</c:v>
                </c:pt>
                <c:pt idx="6">
                  <c:v>68.14817990598084</c:v>
                </c:pt>
                <c:pt idx="7">
                  <c:v>80.58867681132466</c:v>
                </c:pt>
                <c:pt idx="8">
                  <c:v>78.630278352489242</c:v>
                </c:pt>
                <c:pt idx="9">
                  <c:v>87.062869577135956</c:v>
                </c:pt>
                <c:pt idx="10">
                  <c:v>71.934579953557133</c:v>
                </c:pt>
                <c:pt idx="11">
                  <c:v>99.363026134318432</c:v>
                </c:pt>
                <c:pt idx="12">
                  <c:v>98.529271643217783</c:v>
                </c:pt>
                <c:pt idx="13">
                  <c:v>95.387950378576491</c:v>
                </c:pt>
                <c:pt idx="14">
                  <c:v>74.229749137928209</c:v>
                </c:pt>
                <c:pt idx="15">
                  <c:v>160.28214951441913</c:v>
                </c:pt>
                <c:pt idx="16">
                  <c:v>32.484956446926333</c:v>
                </c:pt>
                <c:pt idx="17">
                  <c:v>17.392371016363864</c:v>
                </c:pt>
                <c:pt idx="18">
                  <c:v>58.950746495167607</c:v>
                </c:pt>
                <c:pt idx="19">
                  <c:v>29.538410276255579</c:v>
                </c:pt>
                <c:pt idx="20">
                  <c:v>187.12589580531346</c:v>
                </c:pt>
                <c:pt idx="21">
                  <c:v>133.00863521009944</c:v>
                </c:pt>
                <c:pt idx="22">
                  <c:v>210.03710085676198</c:v>
                </c:pt>
                <c:pt idx="23">
                  <c:v>57.05456689472441</c:v>
                </c:pt>
                <c:pt idx="24">
                  <c:v>56.405455629193376</c:v>
                </c:pt>
                <c:pt idx="25">
                  <c:v>87.964238194509775</c:v>
                </c:pt>
                <c:pt idx="26">
                  <c:v>116.68366698226464</c:v>
                </c:pt>
                <c:pt idx="27">
                  <c:v>78.075887109386429</c:v>
                </c:pt>
                <c:pt idx="28">
                  <c:v>94.388440950223597</c:v>
                </c:pt>
                <c:pt idx="29">
                  <c:v>88.403113215443312</c:v>
                </c:pt>
                <c:pt idx="30">
                  <c:v>80.461716403785658</c:v>
                </c:pt>
                <c:pt idx="31">
                  <c:v>57.967111922638381</c:v>
                </c:pt>
                <c:pt idx="32">
                  <c:v>148.30490310206488</c:v>
                </c:pt>
                <c:pt idx="33">
                  <c:v>58.538004840483246</c:v>
                </c:pt>
                <c:pt idx="34">
                  <c:v>58.720110309431085</c:v>
                </c:pt>
                <c:pt idx="35">
                  <c:v>110.28707469205821</c:v>
                </c:pt>
                <c:pt idx="36">
                  <c:v>72.71915314247687</c:v>
                </c:pt>
                <c:pt idx="37">
                  <c:v>82.909739829656374</c:v>
                </c:pt>
                <c:pt idx="38">
                  <c:v>105.44594369932203</c:v>
                </c:pt>
                <c:pt idx="39">
                  <c:v>124.92213310697646</c:v>
                </c:pt>
                <c:pt idx="40">
                  <c:v>65.991968448394275</c:v>
                </c:pt>
                <c:pt idx="41">
                  <c:v>120.55428678635298</c:v>
                </c:pt>
                <c:pt idx="42">
                  <c:v>89.843262305702197</c:v>
                </c:pt>
                <c:pt idx="43">
                  <c:v>61.620833378458649</c:v>
                </c:pt>
                <c:pt idx="44">
                  <c:v>93.331348628499683</c:v>
                </c:pt>
                <c:pt idx="45">
                  <c:v>78.89839059613611</c:v>
                </c:pt>
                <c:pt idx="46">
                  <c:v>60.4515047390308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B32-4F18-875A-435F797132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66787200"/>
        <c:axId val="28965904"/>
      </c:lineChart>
      <c:catAx>
        <c:axId val="266787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8965904"/>
        <c:crosses val="autoZero"/>
        <c:auto val="1"/>
        <c:lblAlgn val="ctr"/>
        <c:lblOffset val="100"/>
        <c:noMultiLvlLbl val="0"/>
      </c:catAx>
      <c:valAx>
        <c:axId val="289659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667872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1706786395020607"/>
          <c:y val="2.3004925715238767E-2"/>
          <c:w val="0.37984423732083811"/>
          <c:h val="8.22811023320849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FMRシーラント!$M$1:$M$2</c:f>
              <c:strCache>
                <c:ptCount val="2"/>
                <c:pt idx="1">
                  <c:v>SFMR in 2018</c:v>
                </c:pt>
              </c:strCache>
            </c:strRef>
          </c:tx>
          <c:spPr>
            <a:ln w="28575" cap="rnd">
              <a:solidFill>
                <a:schemeClr val="bg1">
                  <a:lumMod val="50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SFMRシーラント!$L$3:$L$50</c:f>
              <c:numCache>
                <c:formatCode>General</c:formatCode>
                <c:ptCount val="4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SFMRシーラント!$M$3:$M$50</c:f>
              <c:numCache>
                <c:formatCode>General</c:formatCode>
                <c:ptCount val="48"/>
                <c:pt idx="0">
                  <c:v>28.6</c:v>
                </c:pt>
                <c:pt idx="1">
                  <c:v>14.7</c:v>
                </c:pt>
                <c:pt idx="2">
                  <c:v>9.1</c:v>
                </c:pt>
                <c:pt idx="3">
                  <c:v>5.5</c:v>
                </c:pt>
                <c:pt idx="4">
                  <c:v>78.2</c:v>
                </c:pt>
                <c:pt idx="5">
                  <c:v>7</c:v>
                </c:pt>
                <c:pt idx="6">
                  <c:v>26</c:v>
                </c:pt>
                <c:pt idx="7">
                  <c:v>1</c:v>
                </c:pt>
                <c:pt idx="8">
                  <c:v>10.199999999999999</c:v>
                </c:pt>
                <c:pt idx="9">
                  <c:v>1.7</c:v>
                </c:pt>
                <c:pt idx="10">
                  <c:v>9.6</c:v>
                </c:pt>
                <c:pt idx="11">
                  <c:v>5.3</c:v>
                </c:pt>
                <c:pt idx="12">
                  <c:v>0</c:v>
                </c:pt>
                <c:pt idx="13">
                  <c:v>0.1</c:v>
                </c:pt>
                <c:pt idx="14">
                  <c:v>73.7</c:v>
                </c:pt>
                <c:pt idx="15">
                  <c:v>30</c:v>
                </c:pt>
                <c:pt idx="16">
                  <c:v>0.7</c:v>
                </c:pt>
                <c:pt idx="17">
                  <c:v>4.8</c:v>
                </c:pt>
                <c:pt idx="18">
                  <c:v>0.8</c:v>
                </c:pt>
                <c:pt idx="19">
                  <c:v>14.8</c:v>
                </c:pt>
                <c:pt idx="20">
                  <c:v>23.3</c:v>
                </c:pt>
                <c:pt idx="21">
                  <c:v>11.6</c:v>
                </c:pt>
                <c:pt idx="22">
                  <c:v>20.6</c:v>
                </c:pt>
                <c:pt idx="23">
                  <c:v>3</c:v>
                </c:pt>
                <c:pt idx="24">
                  <c:v>14.1</c:v>
                </c:pt>
                <c:pt idx="25">
                  <c:v>42.8</c:v>
                </c:pt>
                <c:pt idx="26">
                  <c:v>0.1</c:v>
                </c:pt>
                <c:pt idx="27">
                  <c:v>2.8</c:v>
                </c:pt>
                <c:pt idx="28">
                  <c:v>1.4</c:v>
                </c:pt>
                <c:pt idx="29">
                  <c:v>20.399999999999999</c:v>
                </c:pt>
                <c:pt idx="30">
                  <c:v>8.9</c:v>
                </c:pt>
                <c:pt idx="31">
                  <c:v>40.4</c:v>
                </c:pt>
                <c:pt idx="32">
                  <c:v>1.9</c:v>
                </c:pt>
                <c:pt idx="33">
                  <c:v>0.5</c:v>
                </c:pt>
                <c:pt idx="34">
                  <c:v>32.5</c:v>
                </c:pt>
                <c:pt idx="35">
                  <c:v>1.4</c:v>
                </c:pt>
                <c:pt idx="36">
                  <c:v>23.2</c:v>
                </c:pt>
                <c:pt idx="37">
                  <c:v>23.8</c:v>
                </c:pt>
                <c:pt idx="38">
                  <c:v>28.2</c:v>
                </c:pt>
                <c:pt idx="39">
                  <c:v>1</c:v>
                </c:pt>
                <c:pt idx="40">
                  <c:v>84.7</c:v>
                </c:pt>
                <c:pt idx="41">
                  <c:v>72.5</c:v>
                </c:pt>
                <c:pt idx="42">
                  <c:v>53.7</c:v>
                </c:pt>
                <c:pt idx="43">
                  <c:v>27.9</c:v>
                </c:pt>
                <c:pt idx="44">
                  <c:v>51.7</c:v>
                </c:pt>
                <c:pt idx="45">
                  <c:v>11.5</c:v>
                </c:pt>
                <c:pt idx="46">
                  <c:v>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D02-4B65-812B-9C6A43E7ED5C}"/>
            </c:ext>
          </c:extLst>
        </c:ser>
        <c:ser>
          <c:idx val="1"/>
          <c:order val="1"/>
          <c:tx>
            <c:strRef>
              <c:f>SFMRシーラント!$N$1:$N$2</c:f>
              <c:strCache>
                <c:ptCount val="2"/>
                <c:pt idx="1">
                  <c:v>Dental sealant in 2018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FMRシーラント!$L$3:$L$50</c:f>
              <c:numCache>
                <c:formatCode>General</c:formatCode>
                <c:ptCount val="4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SFMRシーラント!$N$3:$N$50</c:f>
              <c:numCache>
                <c:formatCode>General</c:formatCode>
                <c:ptCount val="48"/>
                <c:pt idx="0">
                  <c:v>98.797212000000002</c:v>
                </c:pt>
                <c:pt idx="1">
                  <c:v>83.281737000000007</c:v>
                </c:pt>
                <c:pt idx="2">
                  <c:v>62.091808999999998</c:v>
                </c:pt>
                <c:pt idx="3">
                  <c:v>84.676644999999994</c:v>
                </c:pt>
                <c:pt idx="4">
                  <c:v>77.038687999999993</c:v>
                </c:pt>
                <c:pt idx="5">
                  <c:v>109.79143000000001</c:v>
                </c:pt>
                <c:pt idx="6">
                  <c:v>59.941687999999999</c:v>
                </c:pt>
                <c:pt idx="7">
                  <c:v>81.469843999999995</c:v>
                </c:pt>
                <c:pt idx="8">
                  <c:v>78.596374999999995</c:v>
                </c:pt>
                <c:pt idx="9">
                  <c:v>82.765281000000002</c:v>
                </c:pt>
                <c:pt idx="10">
                  <c:v>64.033680000000004</c:v>
                </c:pt>
                <c:pt idx="11">
                  <c:v>99.187318000000005</c:v>
                </c:pt>
                <c:pt idx="12">
                  <c:v>92.293880999999999</c:v>
                </c:pt>
                <c:pt idx="13">
                  <c:v>100.35664</c:v>
                </c:pt>
                <c:pt idx="14">
                  <c:v>64.544197999999994</c:v>
                </c:pt>
                <c:pt idx="15">
                  <c:v>165.42227</c:v>
                </c:pt>
                <c:pt idx="16">
                  <c:v>27.221311</c:v>
                </c:pt>
                <c:pt idx="17">
                  <c:v>27.117438</c:v>
                </c:pt>
                <c:pt idx="18">
                  <c:v>61.900042999999997</c:v>
                </c:pt>
                <c:pt idx="19">
                  <c:v>30.916022000000002</c:v>
                </c:pt>
                <c:pt idx="20">
                  <c:v>187.96235999999999</c:v>
                </c:pt>
                <c:pt idx="21">
                  <c:v>123.52977</c:v>
                </c:pt>
                <c:pt idx="22">
                  <c:v>230.36707999999999</c:v>
                </c:pt>
                <c:pt idx="23">
                  <c:v>47.365287000000002</c:v>
                </c:pt>
                <c:pt idx="24">
                  <c:v>53.590699000000001</c:v>
                </c:pt>
                <c:pt idx="25">
                  <c:v>86.227984000000006</c:v>
                </c:pt>
                <c:pt idx="26">
                  <c:v>121.69179</c:v>
                </c:pt>
                <c:pt idx="27">
                  <c:v>77.737530000000007</c:v>
                </c:pt>
                <c:pt idx="28">
                  <c:v>95.256992999999994</c:v>
                </c:pt>
                <c:pt idx="29">
                  <c:v>103.39028999999999</c:v>
                </c:pt>
                <c:pt idx="30">
                  <c:v>74.541892000000004</c:v>
                </c:pt>
                <c:pt idx="31">
                  <c:v>56.413006000000003</c:v>
                </c:pt>
                <c:pt idx="32">
                  <c:v>137.14388</c:v>
                </c:pt>
                <c:pt idx="33">
                  <c:v>59.371248000000001</c:v>
                </c:pt>
                <c:pt idx="34">
                  <c:v>56.969222000000002</c:v>
                </c:pt>
                <c:pt idx="35">
                  <c:v>109.5925</c:v>
                </c:pt>
                <c:pt idx="36">
                  <c:v>77.307886999999994</c:v>
                </c:pt>
                <c:pt idx="37">
                  <c:v>73.486677999999998</c:v>
                </c:pt>
                <c:pt idx="38">
                  <c:v>101.08328</c:v>
                </c:pt>
                <c:pt idx="39">
                  <c:v>137.00036</c:v>
                </c:pt>
                <c:pt idx="40">
                  <c:v>78.206599999999995</c:v>
                </c:pt>
                <c:pt idx="41">
                  <c:v>122.57802</c:v>
                </c:pt>
                <c:pt idx="42">
                  <c:v>95.622502999999995</c:v>
                </c:pt>
                <c:pt idx="43">
                  <c:v>61.434446999999999</c:v>
                </c:pt>
                <c:pt idx="44">
                  <c:v>86.830699999999993</c:v>
                </c:pt>
                <c:pt idx="45">
                  <c:v>71.051421000000005</c:v>
                </c:pt>
                <c:pt idx="46">
                  <c:v>59.362150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D02-4B65-812B-9C6A43E7ED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42919312"/>
        <c:axId val="266230992"/>
      </c:lineChart>
      <c:catAx>
        <c:axId val="1242919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66230992"/>
        <c:crosses val="autoZero"/>
        <c:auto val="1"/>
        <c:lblAlgn val="ctr"/>
        <c:lblOffset val="100"/>
        <c:noMultiLvlLbl val="0"/>
      </c:catAx>
      <c:valAx>
        <c:axId val="2662309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242919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1927642497618196"/>
          <c:y val="4.3086271183096922E-2"/>
          <c:w val="0.37984423732083811"/>
          <c:h val="8.30795726316895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3DC77-A271-59F5-D55A-34C37773D8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27E775-A75E-72C3-8B29-D00DB28C30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3334CE-66D1-01BC-0892-9FDC7756E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F20D4A-A2B7-4470-09C6-6E85CF6E8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D0B358-E515-6038-8FE4-CEE486746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79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6F22B9-3D77-2A8E-3B09-6786753F0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10BF24-9BE9-32E4-7A83-A0DC2398B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99C77-A68E-BBA4-6FAE-7EB6DB5F7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E6ECA1-0675-CEA1-77A3-B6B183A1B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217A69-7625-BA8D-A570-B257F8D6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53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05D4B15-19F5-1B26-7E9A-BFCFB6EE4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776D627-F637-0A82-C18D-0CAA2B9F9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212BFC-389F-91B6-5510-932A6B27A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F69F6F-956E-B0C0-4E41-0B3D70EF4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9DA32D-9D7A-7090-5B44-486932F20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360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4A640D-60D2-0DAB-326C-DAD962557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33413-7D16-8BD1-159F-5783A08AE8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9B6378-0983-38D7-C3F3-391E54065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360BA4-C8B4-E86D-DDBA-C96EAF3CC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5B040C-451A-3FDC-9815-78C46D36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74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812DA3-EAC7-0466-D0A7-74726EDDD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8063543-00C5-F06C-F901-5F4736FF8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0C0D54-E11D-2100-1082-390CCB3A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928D9F-4A3F-A193-0356-3A7FFD0CC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8EDF2B-B3F8-7088-D440-177F6F00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35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E370C3-7288-E156-4CDA-CD12C7B7C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9AC83A-CCD3-CF9B-0842-9FA65EA0DD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2069E7-CE31-B14E-8F15-725348EE9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FF16AE-8A3E-46D7-ACD5-60223AAA5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0D6DD9-DFA9-DB84-AD1D-6D81E16B2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0F7F54-6ABD-98FB-EBEE-BBAB12978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184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70DA7C-2594-6C9F-015A-D96E96EA4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07476A-37D1-F63A-B228-1803DD9C1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329D0D-3C75-C050-9AA8-046501921D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396B8A3-F18B-FA21-3E7F-55B7CE264E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5F0172-07E9-1BD1-4BE6-274DF4C468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A39993C-D8A7-86A7-419D-8CC9B9B90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920688-ABFA-3F8E-4ECA-27A58870F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B328E0D-17D3-AA06-0F66-9FA3D9AB3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512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E4B0CF-A5B3-0B82-2CEC-39CDF3062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65D74F-64C2-A671-482B-553D8D371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484A4E-E892-278F-9ABA-B3B7D642E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D527508-3A04-46BC-638E-1CF59DEB1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62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D4C87BA-3A7F-83B6-2763-7F44FCE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BF0517-E863-0C9E-AD5A-97E1DEB5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E4E00F-1C47-9276-6B92-1112BD169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990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253E4-B1B1-3DB8-F98E-67A83577D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3D5132-A9BE-D52F-5E9A-44869C6CFA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E9A37D-6D13-4556-5993-EFD57CF2A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E6028F-C45A-C768-F3DF-1A3EBCE3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257CB5-2ED2-E0FF-A6D9-11B1DEE2C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16789D-CD1A-4DE9-5261-9B76E5A4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45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DCE48B-160C-A889-6685-7D50FCE3F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D3D4F2-8379-7544-D556-9158BA6C16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BE937E-A323-8E2F-91B8-6B6A2197C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343373-95E2-E9CA-DE03-BDF23F65B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194E29-7F03-0BF8-973F-56C22C696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16E4EE-F028-D2C6-7702-24616E674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97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E57FFD-B15E-6F48-E2AA-38710242D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D1A6F5-FCEB-53E1-DA29-F7D97EA11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3D23F2-F598-4B43-7FAD-03E8CE714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3A2A1F-FDBB-B79D-0684-734F8655BF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495D6E-2C5B-2860-08A9-652075FE37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74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38092FAA-19D1-478D-0A6F-1EB2AF119002}"/>
              </a:ext>
            </a:extLst>
          </p:cNvPr>
          <p:cNvGraphicFramePr>
            <a:graphicFrameLocks/>
          </p:cNvGraphicFramePr>
          <p:nvPr/>
        </p:nvGraphicFramePr>
        <p:xfrm>
          <a:off x="675591" y="9547"/>
          <a:ext cx="11500701" cy="26865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1BC73509-DDEB-8F88-43FB-2B02A0D3D377}"/>
              </a:ext>
            </a:extLst>
          </p:cNvPr>
          <p:cNvGraphicFramePr>
            <a:graphicFrameLocks/>
          </p:cNvGraphicFramePr>
          <p:nvPr/>
        </p:nvGraphicFramePr>
        <p:xfrm>
          <a:off x="675590" y="2970808"/>
          <a:ext cx="11500701" cy="26865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8124299-DF7C-7B07-2508-B2110A0D5BE5}"/>
              </a:ext>
            </a:extLst>
          </p:cNvPr>
          <p:cNvCxnSpPr>
            <a:cxnSpLocks/>
          </p:cNvCxnSpPr>
          <p:nvPr/>
        </p:nvCxnSpPr>
        <p:spPr>
          <a:xfrm>
            <a:off x="1236967" y="9547"/>
            <a:ext cx="0" cy="190927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3595DD6C-938F-31FC-F30C-3229B9CD7525}"/>
              </a:ext>
            </a:extLst>
          </p:cNvPr>
          <p:cNvCxnSpPr>
            <a:cxnSpLocks/>
          </p:cNvCxnSpPr>
          <p:nvPr/>
        </p:nvCxnSpPr>
        <p:spPr>
          <a:xfrm flipH="1">
            <a:off x="1225488" y="1899968"/>
            <a:ext cx="10679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3997FD05-75EA-DB7F-9AE9-320872926D44}"/>
              </a:ext>
            </a:extLst>
          </p:cNvPr>
          <p:cNvCxnSpPr>
            <a:cxnSpLocks/>
          </p:cNvCxnSpPr>
          <p:nvPr/>
        </p:nvCxnSpPr>
        <p:spPr>
          <a:xfrm>
            <a:off x="1229112" y="2976123"/>
            <a:ext cx="0" cy="190927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5C48EB57-7D4D-EAEB-5BB5-58C3454A6003}"/>
              </a:ext>
            </a:extLst>
          </p:cNvPr>
          <p:cNvCxnSpPr>
            <a:cxnSpLocks/>
          </p:cNvCxnSpPr>
          <p:nvPr/>
        </p:nvCxnSpPr>
        <p:spPr>
          <a:xfrm flipH="1">
            <a:off x="1217633" y="4866544"/>
            <a:ext cx="10679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EC86FBC-17D5-83AE-54A0-12D7D28F6878}"/>
              </a:ext>
            </a:extLst>
          </p:cNvPr>
          <p:cNvSpPr txBox="1"/>
          <p:nvPr/>
        </p:nvSpPr>
        <p:spPr>
          <a:xfrm>
            <a:off x="15708" y="594851"/>
            <a:ext cx="73293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</a:t>
            </a:r>
          </a:p>
          <a:p>
            <a:r>
              <a:rPr lang="en-US" altLang="ja-JP" dirty="0"/>
              <a:t>or</a:t>
            </a:r>
          </a:p>
          <a:p>
            <a:r>
              <a:rPr lang="en-US" altLang="ja-JP" dirty="0"/>
              <a:t>%</a:t>
            </a:r>
            <a:endParaRPr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9241D30-0D2F-26AF-01F4-544A7C43ABF2}"/>
              </a:ext>
            </a:extLst>
          </p:cNvPr>
          <p:cNvSpPr txBox="1"/>
          <p:nvPr/>
        </p:nvSpPr>
        <p:spPr>
          <a:xfrm>
            <a:off x="5529178" y="5171452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fectur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F2B1426-1FFD-2CCD-D3E7-7ACB11A3A926}"/>
              </a:ext>
            </a:extLst>
          </p:cNvPr>
          <p:cNvSpPr txBox="1"/>
          <p:nvPr/>
        </p:nvSpPr>
        <p:spPr>
          <a:xfrm>
            <a:off x="5529178" y="2169932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fectur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3C5EFC0-4D67-E48C-17EA-FD6A705B76F4}"/>
              </a:ext>
            </a:extLst>
          </p:cNvPr>
          <p:cNvSpPr txBox="1"/>
          <p:nvPr/>
        </p:nvSpPr>
        <p:spPr>
          <a:xfrm>
            <a:off x="15708" y="3236276"/>
            <a:ext cx="73293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</a:t>
            </a:r>
          </a:p>
          <a:p>
            <a:r>
              <a:rPr lang="en-US" altLang="ja-JP" dirty="0"/>
              <a:t>or</a:t>
            </a:r>
          </a:p>
          <a:p>
            <a:r>
              <a:rPr lang="en-US" altLang="ja-JP" dirty="0"/>
              <a:t>%</a:t>
            </a:r>
            <a:endParaRPr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3A761EC-A8DE-C793-0D44-DD21BD78FF95}"/>
              </a:ext>
            </a:extLst>
          </p:cNvPr>
          <p:cNvSpPr txBox="1"/>
          <p:nvPr/>
        </p:nvSpPr>
        <p:spPr>
          <a:xfrm>
            <a:off x="345649" y="5590680"/>
            <a:ext cx="11500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FM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chool-based fluoride mouth-rinse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; standard claim ratio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921DEB-8ACF-E1C4-857B-AD4AEF2C6C34}"/>
              </a:ext>
            </a:extLst>
          </p:cNvPr>
          <p:cNvSpPr txBox="1"/>
          <p:nvPr/>
        </p:nvSpPr>
        <p:spPr>
          <a:xfrm>
            <a:off x="331695" y="6177180"/>
            <a:ext cx="1151481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The distribution of S-FMR and dental sealant among prefectures in 2016 and 2018</a:t>
            </a:r>
            <a:endParaRPr lang="ja-JP" altLang="en-US" sz="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s: A figure showing the relationship between the implementation rates of the S-FMR and the SCR of dental sealants in each prefecture in 2016 and 2018.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3222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4</Words>
  <Application>Microsoft Office PowerPoint</Application>
  <PresentationFormat>ワイド画面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貴文</dc:creator>
  <cp:lastModifiedBy>takafumi yamamoto</cp:lastModifiedBy>
  <cp:revision>8</cp:revision>
  <dcterms:created xsi:type="dcterms:W3CDTF">2023-12-07T06:34:18Z</dcterms:created>
  <dcterms:modified xsi:type="dcterms:W3CDTF">2024-02-12T23:22:18Z</dcterms:modified>
</cp:coreProperties>
</file>